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0CEED3A-91B6-463A-9B15-A5539187AC23}" v="37" dt="2025-10-10T10:48:53.7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1166" y="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028EFE-6EAA-4E2A-9AEF-808B3D1ADB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974FE7E-1D64-BCBE-1B76-144248A582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EEECA8D-7015-BD49-BF01-B3CF31EF4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D010653-50B8-5981-F945-C7F980C5A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72432A6-8384-BDE4-47D2-19D98CD95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0325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EB09898-380E-C037-948C-5E6645467D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404DB03-A032-1361-7CE8-A02A79801E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FF34BF9-2111-408C-A416-B569009B5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3A7C8A9-824A-6D2D-6F3A-A34607C10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08D6A5D-1028-2092-E31E-47A0ADEC5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3568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FFD8A23-8C9D-0900-1D77-D363A40571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765601A-4CFA-D700-455A-094297D335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E542E4-213A-0FA6-948C-6434740E3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3511C59-9EE7-FD03-227A-65B312D3B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2A0F470-4DD3-64E6-DDB6-70C14D88F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5220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6ECF4C5-4CBC-19CC-3BB3-3B1B286230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7299A0D-EE33-D194-AF94-5678B973F7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AB38C7F-DF6B-982D-45F3-CC83603D4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BAD2CC2-D6E7-4F70-432B-DE996399C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DB2E8D2-BDB2-0162-D0A3-F2897C580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6566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78E32D4-63A4-CA5B-F76A-3D6D24BFA3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8E1C138-3FBE-0251-B998-312C7AB50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5869AE4-56EE-13D7-BDC8-9A5EB35E8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93102CD-E9FB-F88E-FE5D-575B72195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8EB6BB1-CAA0-CAAE-F7DA-7411DB51B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8328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186B0A-EA1F-245C-38A6-8369227F0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E1F2BC-42D8-F1EF-4CEA-81BFEBC96F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2F94ADF-0E7C-5CFD-C9ED-C38BC29D86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67DA006-9130-6FA9-0003-6CAB61BC9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BB218C4-1D01-957E-45BC-4E62C0F83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79C1E8D-5956-3C2B-5B8C-C1031607A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315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807C2A-DA93-1BED-C799-D464C8F1C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19F21C0-E200-76B0-2D6C-9AFCA9A35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57238A3-6EC8-B514-1D16-FD8C2717F7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69A96B0-09D6-A394-876D-77DF92434A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513AA2E-6244-DBCA-0789-CC973F394A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E73C8C4-1E97-BCD6-7BC4-62EBD31E4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649371F5-CE4B-A98C-31CD-C3A4C899A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5889FA1-C030-2688-254A-CEADF6930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2572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997585-66BA-47FE-8CE9-8348CFAB5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C185663-31D2-3657-0D32-AD18E3208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D6ED46F-49A4-15DB-AD92-F9C35E55A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751B433-6D1E-0AED-FB0F-E76F1C110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4610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7F00847-85F5-D38B-2445-DFE1AF430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115AB3F-0226-C2AF-74A9-9E102432D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F2AE063-9C01-3E19-31CD-53BBACEC5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8850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8DACC2-265F-3761-54ED-8151ADB0B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16664CA-DBA0-0B55-8727-E3C62A1847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4083AE4-AC19-67BD-CBA3-D8293A3C7B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6069604-1E88-CBEE-2A18-C0EDA78C8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43E062A-7D65-C572-B6CE-BE39FE239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4856AFF-5ACA-D1CA-6FE6-604DCDF24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6051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63BDA30-D8A7-78EA-C7A4-AA09BE2479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0E785B4-4705-E234-E5C4-8B0BE78442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34334B6-4193-2572-8B57-06372ED35D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B2A5D25-5766-6F61-93C4-6C7C1A48E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8F2E330-5B6D-E606-C361-70D80F127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2FE8AC9-33EA-E785-9437-43C59A659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76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B41C819-3C83-EBD9-500B-2E4E49F7B2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1281A16-DDD1-414D-5C4C-E0F21413AC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9B0D26A-3F90-C154-974E-6703E7403C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E742B0-FA05-4D93-80B1-B4B16F1FCEF0}" type="datetimeFigureOut">
              <a:rPr lang="it-IT" smtClean="0"/>
              <a:t>19/02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396AEA7-E9F9-6DC2-6C98-FC867D9A45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E00AA9F-B829-0640-3E04-B341D65D2B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864537-6530-447E-9F92-38DD9C45DF3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8994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3.png"/><Relationship Id="rId7" Type="http://schemas.openxmlformats.org/officeDocument/2006/relationships/image" Target="../media/image16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Object0">
            <a:extLst>
              <a:ext uri="{FF2B5EF4-FFF2-40B4-BE49-F238E27FC236}">
                <a16:creationId xmlns:a16="http://schemas.microsoft.com/office/drawing/2014/main" id="{974F1319-7A82-CE84-4BF2-FD35D6F233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04797"/>
            <a:ext cx="3597275" cy="17065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Object1">
            <a:extLst>
              <a:ext uri="{FF2B5EF4-FFF2-40B4-BE49-F238E27FC236}">
                <a16:creationId xmlns:a16="http://schemas.microsoft.com/office/drawing/2014/main" id="{7CB5C0BD-A0B4-3D70-04E0-085FF5C0C0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972" y="1815421"/>
            <a:ext cx="3360738" cy="15922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Object2">
            <a:extLst>
              <a:ext uri="{FF2B5EF4-FFF2-40B4-BE49-F238E27FC236}">
                <a16:creationId xmlns:a16="http://schemas.microsoft.com/office/drawing/2014/main" id="{35658D49-DB58-10F7-EBAB-D42F4789A4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2658" y="3364139"/>
            <a:ext cx="3597275" cy="17065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Object3">
            <a:extLst>
              <a:ext uri="{FF2B5EF4-FFF2-40B4-BE49-F238E27FC236}">
                <a16:creationId xmlns:a16="http://schemas.microsoft.com/office/drawing/2014/main" id="{2758770C-13A4-66E6-E1D2-EC5D7D46469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86" y="4940070"/>
            <a:ext cx="3513138" cy="16684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5">
            <a:extLst>
              <a:ext uri="{FF2B5EF4-FFF2-40B4-BE49-F238E27FC236}">
                <a16:creationId xmlns:a16="http://schemas.microsoft.com/office/drawing/2014/main" id="{4025C4D7-5F87-E613-FE99-1BE0277ECE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772" y="25179"/>
            <a:ext cx="300601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A. Patient Information</a:t>
            </a:r>
            <a:endParaRPr kumimoji="0" lang="it-IT" altLang="zh-CN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zh-CN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2EAD342F-BC1D-6D08-2E64-48FB7C887C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7560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sp>
        <p:nvSpPr>
          <p:cNvPr id="6" name="Rectangle 7">
            <a:extLst>
              <a:ext uri="{FF2B5EF4-FFF2-40B4-BE49-F238E27FC236}">
                <a16:creationId xmlns:a16="http://schemas.microsoft.com/office/drawing/2014/main" id="{B0EFD1A9-F43E-88CA-7473-F3038D0276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71310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48104595-F667-48AD-149F-39469827F440}"/>
              </a:ext>
            </a:extLst>
          </p:cNvPr>
          <p:cNvSpPr txBox="1"/>
          <p:nvPr/>
        </p:nvSpPr>
        <p:spPr>
          <a:xfrm>
            <a:off x="3720193" y="0"/>
            <a:ext cx="6112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8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B. </a:t>
            </a:r>
            <a:r>
              <a:rPr lang="en-US" sz="12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Procedure</a:t>
            </a:r>
            <a:r>
              <a:rPr lang="en-US" sz="18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 Preparation</a:t>
            </a:r>
            <a:endParaRPr lang="it-IT" sz="1800" kern="100" dirty="0">
              <a:effectLst/>
              <a:latin typeface="Liberation Serif"/>
              <a:ea typeface="NSimSun" panose="02010609030101010101" pitchFamily="49" charset="-122"/>
              <a:cs typeface="Lucida Sans" panose="020B0602030504020204" pitchFamily="34" charset="0"/>
            </a:endParaRPr>
          </a:p>
        </p:txBody>
      </p:sp>
      <p:pic>
        <p:nvPicPr>
          <p:cNvPr id="14" name="Object4">
            <a:extLst>
              <a:ext uri="{FF2B5EF4-FFF2-40B4-BE49-F238E27FC236}">
                <a16:creationId xmlns:a16="http://schemas.microsoft.com/office/drawing/2014/main" id="{CEB20CEF-C6F6-558F-099A-4A672E385C0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 bwMode="auto">
          <a:xfrm>
            <a:off x="3727905" y="325553"/>
            <a:ext cx="3599815" cy="1711325"/>
          </a:xfrm>
          <a:prstGeom prst="rect">
            <a:avLst/>
          </a:prstGeom>
          <a:noFill/>
        </p:spPr>
      </p:pic>
      <p:pic>
        <p:nvPicPr>
          <p:cNvPr id="15" name="Object5">
            <a:extLst>
              <a:ext uri="{FF2B5EF4-FFF2-40B4-BE49-F238E27FC236}">
                <a16:creationId xmlns:a16="http://schemas.microsoft.com/office/drawing/2014/main" id="{990921F6-8806-2C8C-C560-76CB56B39A5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 bwMode="auto">
          <a:xfrm>
            <a:off x="3720193" y="1781631"/>
            <a:ext cx="3599815" cy="1711325"/>
          </a:xfrm>
          <a:prstGeom prst="rect">
            <a:avLst/>
          </a:prstGeom>
          <a:noFill/>
        </p:spPr>
      </p:pic>
      <p:pic>
        <p:nvPicPr>
          <p:cNvPr id="16" name="Object6">
            <a:extLst>
              <a:ext uri="{FF2B5EF4-FFF2-40B4-BE49-F238E27FC236}">
                <a16:creationId xmlns:a16="http://schemas.microsoft.com/office/drawing/2014/main" id="{8F5844AB-E370-7573-CFE4-010B4D0FAF8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 bwMode="auto">
          <a:xfrm>
            <a:off x="3801835" y="3346333"/>
            <a:ext cx="3599815" cy="1711325"/>
          </a:xfrm>
          <a:prstGeom prst="rect">
            <a:avLst/>
          </a:prstGeom>
          <a:noFill/>
        </p:spPr>
      </p:pic>
      <p:pic>
        <p:nvPicPr>
          <p:cNvPr id="17" name="Object7">
            <a:extLst>
              <a:ext uri="{FF2B5EF4-FFF2-40B4-BE49-F238E27FC236}">
                <a16:creationId xmlns:a16="http://schemas.microsoft.com/office/drawing/2014/main" id="{C1E99316-C748-F6AD-E132-6FEBF9D9E9E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 bwMode="auto">
          <a:xfrm>
            <a:off x="3801835" y="4897207"/>
            <a:ext cx="3599815" cy="1711325"/>
          </a:xfrm>
          <a:prstGeom prst="rect">
            <a:avLst/>
          </a:prstGeom>
          <a:noFill/>
        </p:spPr>
      </p:pic>
      <p:pic>
        <p:nvPicPr>
          <p:cNvPr id="18" name="Object8">
            <a:extLst>
              <a:ext uri="{FF2B5EF4-FFF2-40B4-BE49-F238E27FC236}">
                <a16:creationId xmlns:a16="http://schemas.microsoft.com/office/drawing/2014/main" id="{B61C2BB2-D54A-30C8-E02C-BBAD7EF8D2C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 bwMode="auto">
          <a:xfrm>
            <a:off x="7627119" y="165389"/>
            <a:ext cx="3599815" cy="1711325"/>
          </a:xfrm>
          <a:prstGeom prst="rect">
            <a:avLst/>
          </a:prstGeom>
          <a:noFill/>
        </p:spPr>
      </p:pic>
      <p:pic>
        <p:nvPicPr>
          <p:cNvPr id="19" name="Object9">
            <a:extLst>
              <a:ext uri="{FF2B5EF4-FFF2-40B4-BE49-F238E27FC236}">
                <a16:creationId xmlns:a16="http://schemas.microsoft.com/office/drawing/2014/main" id="{317CA43C-ABB6-9DBB-7FE3-8BFEEB31781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 bwMode="auto">
          <a:xfrm>
            <a:off x="7730218" y="1878015"/>
            <a:ext cx="3599815" cy="1711325"/>
          </a:xfrm>
          <a:prstGeom prst="rect">
            <a:avLst/>
          </a:prstGeom>
          <a:noFill/>
        </p:spPr>
      </p:pic>
      <p:pic>
        <p:nvPicPr>
          <p:cNvPr id="20" name="Object10">
            <a:extLst>
              <a:ext uri="{FF2B5EF4-FFF2-40B4-BE49-F238E27FC236}">
                <a16:creationId xmlns:a16="http://schemas.microsoft.com/office/drawing/2014/main" id="{C1278472-CB84-659C-3D5A-2437E6C2EAE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 bwMode="auto">
          <a:xfrm>
            <a:off x="7915275" y="3360849"/>
            <a:ext cx="3599815" cy="171132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586530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11">
            <a:extLst>
              <a:ext uri="{FF2B5EF4-FFF2-40B4-BE49-F238E27FC236}">
                <a16:creationId xmlns:a16="http://schemas.microsoft.com/office/drawing/2014/main" id="{497C70C8-868B-0896-1FF0-6066D08735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7990114" y="270778"/>
            <a:ext cx="3599815" cy="1711325"/>
          </a:xfrm>
          <a:prstGeom prst="rect">
            <a:avLst/>
          </a:prstGeom>
          <a:noFill/>
        </p:spPr>
      </p:pic>
      <p:pic>
        <p:nvPicPr>
          <p:cNvPr id="3" name="Object12">
            <a:extLst>
              <a:ext uri="{FF2B5EF4-FFF2-40B4-BE49-F238E27FC236}">
                <a16:creationId xmlns:a16="http://schemas.microsoft.com/office/drawing/2014/main" id="{DB698E96-F682-5B5E-A4CF-1EC67F3BBC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3767818" y="270777"/>
            <a:ext cx="3599815" cy="1711325"/>
          </a:xfrm>
          <a:prstGeom prst="rect">
            <a:avLst/>
          </a:prstGeom>
          <a:noFill/>
        </p:spPr>
      </p:pic>
      <p:pic>
        <p:nvPicPr>
          <p:cNvPr id="4" name="Object10">
            <a:extLst>
              <a:ext uri="{FF2B5EF4-FFF2-40B4-BE49-F238E27FC236}">
                <a16:creationId xmlns:a16="http://schemas.microsoft.com/office/drawing/2014/main" id="{97328429-DEA2-F157-34F0-61B226A870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 bwMode="auto">
          <a:xfrm>
            <a:off x="0" y="270777"/>
            <a:ext cx="3599815" cy="1711325"/>
          </a:xfrm>
          <a:prstGeom prst="rect">
            <a:avLst/>
          </a:prstGeom>
          <a:noFill/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D1359EDC-6951-D7D3-41BB-30C5DDE5BD23}"/>
              </a:ext>
            </a:extLst>
          </p:cNvPr>
          <p:cNvSpPr txBox="1"/>
          <p:nvPr/>
        </p:nvSpPr>
        <p:spPr>
          <a:xfrm>
            <a:off x="3720193" y="0"/>
            <a:ext cx="6112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8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B. </a:t>
            </a:r>
            <a:r>
              <a:rPr lang="en-US" sz="12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Procedure</a:t>
            </a:r>
            <a:r>
              <a:rPr lang="en-US" sz="18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 Preparation</a:t>
            </a:r>
            <a:endParaRPr lang="it-IT" sz="1800" kern="100" dirty="0">
              <a:effectLst/>
              <a:latin typeface="Liberation Serif"/>
              <a:ea typeface="NSimSun" panose="02010609030101010101" pitchFamily="49" charset="-122"/>
              <a:cs typeface="Lucida Sans" panose="020B0602030504020204" pitchFamily="34" charset="0"/>
            </a:endParaRPr>
          </a:p>
        </p:txBody>
      </p:sp>
      <p:pic>
        <p:nvPicPr>
          <p:cNvPr id="7" name="Object13">
            <a:extLst>
              <a:ext uri="{FF2B5EF4-FFF2-40B4-BE49-F238E27FC236}">
                <a16:creationId xmlns:a16="http://schemas.microsoft.com/office/drawing/2014/main" id="{EF95A7F8-450B-51BB-D3A7-F1E48C15A6A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 bwMode="auto">
          <a:xfrm>
            <a:off x="120378" y="2127023"/>
            <a:ext cx="3599815" cy="1711325"/>
          </a:xfrm>
          <a:prstGeom prst="rect">
            <a:avLst/>
          </a:prstGeom>
          <a:noFill/>
        </p:spPr>
      </p:pic>
      <p:pic>
        <p:nvPicPr>
          <p:cNvPr id="8" name="Object14">
            <a:extLst>
              <a:ext uri="{FF2B5EF4-FFF2-40B4-BE49-F238E27FC236}">
                <a16:creationId xmlns:a16="http://schemas.microsoft.com/office/drawing/2014/main" id="{66CC542D-C882-E8AB-2CC2-E3D8218559C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 bwMode="auto">
          <a:xfrm>
            <a:off x="3888196" y="2127023"/>
            <a:ext cx="3599815" cy="1711325"/>
          </a:xfrm>
          <a:prstGeom prst="rect">
            <a:avLst/>
          </a:prstGeom>
          <a:noFill/>
        </p:spPr>
      </p:pic>
      <p:pic>
        <p:nvPicPr>
          <p:cNvPr id="9" name="Object15">
            <a:extLst>
              <a:ext uri="{FF2B5EF4-FFF2-40B4-BE49-F238E27FC236}">
                <a16:creationId xmlns:a16="http://schemas.microsoft.com/office/drawing/2014/main" id="{73527736-849E-A751-0497-B3FECB340F8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 bwMode="auto">
          <a:xfrm>
            <a:off x="8032613" y="2127023"/>
            <a:ext cx="3599815" cy="1711325"/>
          </a:xfrm>
          <a:prstGeom prst="rect">
            <a:avLst/>
          </a:prstGeom>
          <a:noFill/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1C7003EC-6DC5-53B6-E2C9-F871196A9385}"/>
              </a:ext>
            </a:extLst>
          </p:cNvPr>
          <p:cNvSpPr txBox="1"/>
          <p:nvPr/>
        </p:nvSpPr>
        <p:spPr>
          <a:xfrm>
            <a:off x="3720193" y="1685231"/>
            <a:ext cx="6112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8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C. </a:t>
            </a:r>
            <a:r>
              <a:rPr lang="en-US" sz="12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Procedure</a:t>
            </a:r>
            <a:r>
              <a:rPr lang="en-US" sz="1800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 </a:t>
            </a:r>
            <a:r>
              <a:rPr lang="en-US" kern="100" dirty="0" err="1"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Excution</a:t>
            </a:r>
            <a:endParaRPr lang="it-IT" sz="1800" kern="100" dirty="0">
              <a:effectLst/>
              <a:latin typeface="Liberation Serif"/>
              <a:ea typeface="NSimSun" panose="02010609030101010101" pitchFamily="49" charset="-122"/>
              <a:cs typeface="Lucida Sans" panose="020B0602030504020204" pitchFamily="34" charset="0"/>
            </a:endParaRPr>
          </a:p>
        </p:txBody>
      </p:sp>
      <p:pic>
        <p:nvPicPr>
          <p:cNvPr id="11" name="Object15">
            <a:extLst>
              <a:ext uri="{FF2B5EF4-FFF2-40B4-BE49-F238E27FC236}">
                <a16:creationId xmlns:a16="http://schemas.microsoft.com/office/drawing/2014/main" id="{26BACFF4-5843-F5C3-8E62-42309CA32B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 bwMode="auto">
          <a:xfrm>
            <a:off x="168003" y="4086452"/>
            <a:ext cx="3599815" cy="1711325"/>
          </a:xfrm>
          <a:prstGeom prst="rect">
            <a:avLst/>
          </a:prstGeom>
          <a:noFill/>
        </p:spPr>
      </p:pic>
      <p:pic>
        <p:nvPicPr>
          <p:cNvPr id="12" name="Object16">
            <a:extLst>
              <a:ext uri="{FF2B5EF4-FFF2-40B4-BE49-F238E27FC236}">
                <a16:creationId xmlns:a16="http://schemas.microsoft.com/office/drawing/2014/main" id="{56EF0F0A-9C61-F5D7-2444-27841719C1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 bwMode="auto">
          <a:xfrm>
            <a:off x="4198121" y="3947775"/>
            <a:ext cx="3599815" cy="171132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207420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1A3CBADB-F6C9-C2A5-8CD7-07ABC72265ED}"/>
              </a:ext>
            </a:extLst>
          </p:cNvPr>
          <p:cNvSpPr txBox="1"/>
          <p:nvPr/>
        </p:nvSpPr>
        <p:spPr>
          <a:xfrm>
            <a:off x="261257" y="1963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kern="1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D. If Peripheral Block</a:t>
            </a:r>
            <a:endParaRPr lang="it-IT" kern="100" dirty="0">
              <a:effectLst/>
              <a:latin typeface="Liberation Serif"/>
              <a:ea typeface="NSimSun" panose="02010609030101010101" pitchFamily="49" charset="-122"/>
              <a:cs typeface="Lucida Sans" panose="020B0602030504020204" pitchFamily="34" charset="0"/>
            </a:endParaRPr>
          </a:p>
        </p:txBody>
      </p:sp>
      <p:pic>
        <p:nvPicPr>
          <p:cNvPr id="4" name="Object17">
            <a:extLst>
              <a:ext uri="{FF2B5EF4-FFF2-40B4-BE49-F238E27FC236}">
                <a16:creationId xmlns:a16="http://schemas.microsoft.com/office/drawing/2014/main" id="{61A39AFD-5556-82EB-17F7-9C256CDA2A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61257" y="788080"/>
            <a:ext cx="3599815" cy="1711325"/>
          </a:xfrm>
          <a:prstGeom prst="rect">
            <a:avLst/>
          </a:prstGeom>
          <a:noFill/>
        </p:spPr>
      </p:pic>
      <p:pic>
        <p:nvPicPr>
          <p:cNvPr id="5" name="Object18">
            <a:extLst>
              <a:ext uri="{FF2B5EF4-FFF2-40B4-BE49-F238E27FC236}">
                <a16:creationId xmlns:a16="http://schemas.microsoft.com/office/drawing/2014/main" id="{D36B58D2-4CB6-381A-6599-0F87C7129B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3969520" y="788079"/>
            <a:ext cx="3599815" cy="1711325"/>
          </a:xfrm>
          <a:prstGeom prst="rect">
            <a:avLst/>
          </a:prstGeom>
          <a:noFill/>
        </p:spPr>
      </p:pic>
      <p:pic>
        <p:nvPicPr>
          <p:cNvPr id="6" name="Object19">
            <a:extLst>
              <a:ext uri="{FF2B5EF4-FFF2-40B4-BE49-F238E27FC236}">
                <a16:creationId xmlns:a16="http://schemas.microsoft.com/office/drawing/2014/main" id="{873C0CCA-FE85-2DB8-7266-9D37DB2AD6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 bwMode="auto">
          <a:xfrm>
            <a:off x="7844835" y="669969"/>
            <a:ext cx="3599815" cy="1829435"/>
          </a:xfrm>
          <a:prstGeom prst="rect">
            <a:avLst/>
          </a:prstGeom>
          <a:noFill/>
        </p:spPr>
      </p:pic>
      <p:pic>
        <p:nvPicPr>
          <p:cNvPr id="7" name="Object21">
            <a:extLst>
              <a:ext uri="{FF2B5EF4-FFF2-40B4-BE49-F238E27FC236}">
                <a16:creationId xmlns:a16="http://schemas.microsoft.com/office/drawing/2014/main" id="{B327D51B-1261-18B3-35E1-7306F61822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 bwMode="auto">
          <a:xfrm>
            <a:off x="3861070" y="2499403"/>
            <a:ext cx="3599815" cy="1711325"/>
          </a:xfrm>
          <a:prstGeom prst="rect">
            <a:avLst/>
          </a:prstGeom>
          <a:noFill/>
        </p:spPr>
      </p:pic>
      <p:pic>
        <p:nvPicPr>
          <p:cNvPr id="8" name="Object22">
            <a:extLst>
              <a:ext uri="{FF2B5EF4-FFF2-40B4-BE49-F238E27FC236}">
                <a16:creationId xmlns:a16="http://schemas.microsoft.com/office/drawing/2014/main" id="{AEE09EAF-8732-EC1D-C756-35AFDF05EAC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 bwMode="auto">
          <a:xfrm>
            <a:off x="7844835" y="2573336"/>
            <a:ext cx="3599815" cy="1711325"/>
          </a:xfrm>
          <a:prstGeom prst="rect">
            <a:avLst/>
          </a:prstGeom>
          <a:noFill/>
        </p:spPr>
      </p:pic>
      <p:pic>
        <p:nvPicPr>
          <p:cNvPr id="9" name="Object23">
            <a:extLst>
              <a:ext uri="{FF2B5EF4-FFF2-40B4-BE49-F238E27FC236}">
                <a16:creationId xmlns:a16="http://schemas.microsoft.com/office/drawing/2014/main" id="{3FE3401A-35C5-6C42-06A5-713C518153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 bwMode="auto">
          <a:xfrm>
            <a:off x="261255" y="4794023"/>
            <a:ext cx="3599815" cy="1711325"/>
          </a:xfrm>
          <a:prstGeom prst="rect">
            <a:avLst/>
          </a:prstGeom>
          <a:noFill/>
        </p:spPr>
      </p:pic>
      <p:pic>
        <p:nvPicPr>
          <p:cNvPr id="10" name="Object20">
            <a:extLst>
              <a:ext uri="{FF2B5EF4-FFF2-40B4-BE49-F238E27FC236}">
                <a16:creationId xmlns:a16="http://schemas.microsoft.com/office/drawing/2014/main" id="{3CEBBB4A-31A4-AAB6-566D-F8A0F608A6A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 bwMode="auto">
          <a:xfrm>
            <a:off x="261255" y="2399165"/>
            <a:ext cx="3599815" cy="1711325"/>
          </a:xfrm>
          <a:prstGeom prst="rect">
            <a:avLst/>
          </a:prstGeom>
          <a:noFill/>
        </p:spPr>
      </p:pic>
      <p:pic>
        <p:nvPicPr>
          <p:cNvPr id="11" name="Object24">
            <a:extLst>
              <a:ext uri="{FF2B5EF4-FFF2-40B4-BE49-F238E27FC236}">
                <a16:creationId xmlns:a16="http://schemas.microsoft.com/office/drawing/2014/main" id="{69AA46FF-2521-6DCB-C195-0521CC03123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 bwMode="auto">
          <a:xfrm>
            <a:off x="3969520" y="4794022"/>
            <a:ext cx="3599815" cy="171132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785652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8FA62CF9-CD56-43D6-71A7-FC063601AD34}"/>
              </a:ext>
            </a:extLst>
          </p:cNvPr>
          <p:cNvSpPr txBox="1"/>
          <p:nvPr/>
        </p:nvSpPr>
        <p:spPr>
          <a:xfrm>
            <a:off x="163285" y="13102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E. If Central Block</a:t>
            </a:r>
            <a:endParaRPr lang="it-IT" dirty="0"/>
          </a:p>
        </p:txBody>
      </p:sp>
      <p:pic>
        <p:nvPicPr>
          <p:cNvPr id="4" name="Object25">
            <a:extLst>
              <a:ext uri="{FF2B5EF4-FFF2-40B4-BE49-F238E27FC236}">
                <a16:creationId xmlns:a16="http://schemas.microsoft.com/office/drawing/2014/main" id="{52F1501F-34F1-6DF6-179C-F32958EF16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163285" y="777195"/>
            <a:ext cx="3599815" cy="1711325"/>
          </a:xfrm>
          <a:prstGeom prst="rect">
            <a:avLst/>
          </a:prstGeom>
          <a:noFill/>
        </p:spPr>
      </p:pic>
      <p:pic>
        <p:nvPicPr>
          <p:cNvPr id="5" name="Object26">
            <a:extLst>
              <a:ext uri="{FF2B5EF4-FFF2-40B4-BE49-F238E27FC236}">
                <a16:creationId xmlns:a16="http://schemas.microsoft.com/office/drawing/2014/main" id="{0FF152FB-6FCC-E96D-C6E3-46C9A53390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4002177" y="777195"/>
            <a:ext cx="3599815" cy="1711325"/>
          </a:xfrm>
          <a:prstGeom prst="rect">
            <a:avLst/>
          </a:prstGeom>
          <a:noFill/>
        </p:spPr>
      </p:pic>
      <p:pic>
        <p:nvPicPr>
          <p:cNvPr id="6" name="Object27">
            <a:extLst>
              <a:ext uri="{FF2B5EF4-FFF2-40B4-BE49-F238E27FC236}">
                <a16:creationId xmlns:a16="http://schemas.microsoft.com/office/drawing/2014/main" id="{E7E4470B-5199-6678-30B3-A3D242796A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 bwMode="auto">
          <a:xfrm>
            <a:off x="7841069" y="659085"/>
            <a:ext cx="3599815" cy="1829435"/>
          </a:xfrm>
          <a:prstGeom prst="rect">
            <a:avLst/>
          </a:prstGeom>
          <a:noFill/>
        </p:spPr>
      </p:pic>
      <p:pic>
        <p:nvPicPr>
          <p:cNvPr id="7" name="Object28">
            <a:extLst>
              <a:ext uri="{FF2B5EF4-FFF2-40B4-BE49-F238E27FC236}">
                <a16:creationId xmlns:a16="http://schemas.microsoft.com/office/drawing/2014/main" id="{93EBD3E2-3A9A-FD21-BFCC-7F15F4855C3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 bwMode="auto">
          <a:xfrm>
            <a:off x="163285" y="2787134"/>
            <a:ext cx="3599815" cy="1711325"/>
          </a:xfrm>
          <a:prstGeom prst="rect">
            <a:avLst/>
          </a:prstGeom>
          <a:noFill/>
        </p:spPr>
      </p:pic>
      <p:pic>
        <p:nvPicPr>
          <p:cNvPr id="8" name="Object29">
            <a:extLst>
              <a:ext uri="{FF2B5EF4-FFF2-40B4-BE49-F238E27FC236}">
                <a16:creationId xmlns:a16="http://schemas.microsoft.com/office/drawing/2014/main" id="{01C8C0AA-A8CA-4CCB-ECD2-AC4386DAB21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 bwMode="auto">
          <a:xfrm>
            <a:off x="4002177" y="2798020"/>
            <a:ext cx="3599815" cy="1711325"/>
          </a:xfrm>
          <a:prstGeom prst="rect">
            <a:avLst/>
          </a:prstGeom>
          <a:noFill/>
        </p:spPr>
      </p:pic>
      <p:pic>
        <p:nvPicPr>
          <p:cNvPr id="9" name="Object30">
            <a:extLst>
              <a:ext uri="{FF2B5EF4-FFF2-40B4-BE49-F238E27FC236}">
                <a16:creationId xmlns:a16="http://schemas.microsoft.com/office/drawing/2014/main" id="{58070325-1DEC-658E-6DAD-A9493FFB94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 bwMode="auto">
          <a:xfrm>
            <a:off x="7841068" y="2798020"/>
            <a:ext cx="3599815" cy="1711325"/>
          </a:xfrm>
          <a:prstGeom prst="rect">
            <a:avLst/>
          </a:prstGeom>
          <a:noFill/>
        </p:spPr>
      </p:pic>
      <p:pic>
        <p:nvPicPr>
          <p:cNvPr id="10" name="Object31">
            <a:extLst>
              <a:ext uri="{FF2B5EF4-FFF2-40B4-BE49-F238E27FC236}">
                <a16:creationId xmlns:a16="http://schemas.microsoft.com/office/drawing/2014/main" id="{26E0606E-43A0-5A6C-7691-A6CC61EE9B0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 bwMode="auto">
          <a:xfrm>
            <a:off x="163284" y="4509345"/>
            <a:ext cx="3599815" cy="1711325"/>
          </a:xfrm>
          <a:prstGeom prst="rect">
            <a:avLst/>
          </a:prstGeom>
          <a:noFill/>
        </p:spPr>
      </p:pic>
      <p:pic>
        <p:nvPicPr>
          <p:cNvPr id="11" name="Object32">
            <a:extLst>
              <a:ext uri="{FF2B5EF4-FFF2-40B4-BE49-F238E27FC236}">
                <a16:creationId xmlns:a16="http://schemas.microsoft.com/office/drawing/2014/main" id="{C50BB459-4B95-22B8-7641-DAF4238460C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 bwMode="auto">
          <a:xfrm>
            <a:off x="4002175" y="4391235"/>
            <a:ext cx="3599815" cy="1829435"/>
          </a:xfrm>
          <a:prstGeom prst="rect">
            <a:avLst/>
          </a:prstGeom>
          <a:noFill/>
        </p:spPr>
      </p:pic>
      <p:pic>
        <p:nvPicPr>
          <p:cNvPr id="12" name="Object33">
            <a:extLst>
              <a:ext uri="{FF2B5EF4-FFF2-40B4-BE49-F238E27FC236}">
                <a16:creationId xmlns:a16="http://schemas.microsoft.com/office/drawing/2014/main" id="{536EF0B4-C33A-693A-F89D-94C363294F5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 bwMode="auto">
          <a:xfrm>
            <a:off x="7964578" y="4450289"/>
            <a:ext cx="3599815" cy="171132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3279100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B20606-612F-B376-F80D-B7F0C45893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4F5355DA-E381-D0AF-9E0F-FE3AB37419DB}"/>
              </a:ext>
            </a:extLst>
          </p:cNvPr>
          <p:cNvSpPr txBox="1"/>
          <p:nvPr/>
        </p:nvSpPr>
        <p:spPr>
          <a:xfrm>
            <a:off x="163285" y="13102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E. If Central Block</a:t>
            </a:r>
            <a:endParaRPr lang="it-IT" dirty="0"/>
          </a:p>
        </p:txBody>
      </p:sp>
      <p:pic>
        <p:nvPicPr>
          <p:cNvPr id="2" name="Object34">
            <a:extLst>
              <a:ext uri="{FF2B5EF4-FFF2-40B4-BE49-F238E27FC236}">
                <a16:creationId xmlns:a16="http://schemas.microsoft.com/office/drawing/2014/main" id="{92C5593A-68D9-1F2F-4F28-CD19FC23C0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163285" y="565666"/>
            <a:ext cx="3599815" cy="1711325"/>
          </a:xfrm>
          <a:prstGeom prst="rect">
            <a:avLst/>
          </a:prstGeom>
          <a:noFill/>
        </p:spPr>
      </p:pic>
      <p:pic>
        <p:nvPicPr>
          <p:cNvPr id="13" name="Object35">
            <a:extLst>
              <a:ext uri="{FF2B5EF4-FFF2-40B4-BE49-F238E27FC236}">
                <a16:creationId xmlns:a16="http://schemas.microsoft.com/office/drawing/2014/main" id="{467ED961-2623-F26B-425F-6068E4754A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3763100" y="500352"/>
            <a:ext cx="3599815" cy="1711325"/>
          </a:xfrm>
          <a:prstGeom prst="rect">
            <a:avLst/>
          </a:prstGeom>
          <a:noFill/>
        </p:spPr>
      </p:pic>
      <p:pic>
        <p:nvPicPr>
          <p:cNvPr id="14" name="Object36">
            <a:extLst>
              <a:ext uri="{FF2B5EF4-FFF2-40B4-BE49-F238E27FC236}">
                <a16:creationId xmlns:a16="http://schemas.microsoft.com/office/drawing/2014/main" id="{19F32868-5593-E93A-D347-F06273362D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 bwMode="auto">
          <a:xfrm>
            <a:off x="7833950" y="500351"/>
            <a:ext cx="3599815" cy="1711325"/>
          </a:xfrm>
          <a:prstGeom prst="rect">
            <a:avLst/>
          </a:prstGeom>
          <a:noFill/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DC4C1C7A-924B-BECA-2306-20033E2A7E1F}"/>
              </a:ext>
            </a:extLst>
          </p:cNvPr>
          <p:cNvSpPr txBox="1"/>
          <p:nvPr/>
        </p:nvSpPr>
        <p:spPr>
          <a:xfrm>
            <a:off x="4314915" y="23205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Section E. </a:t>
            </a:r>
            <a:r>
              <a:rPr lang="en-US" dirty="0">
                <a:latin typeface="Liberation Serif"/>
                <a:ea typeface="NSimSun" panose="02010609030101010101" pitchFamily="49" charset="-122"/>
                <a:cs typeface="Lucida Sans" panose="020B0602030504020204" pitchFamily="34" charset="0"/>
              </a:rPr>
              <a:t>Post procedural</a:t>
            </a:r>
            <a:endParaRPr lang="it-IT" dirty="0"/>
          </a:p>
        </p:txBody>
      </p:sp>
      <p:pic>
        <p:nvPicPr>
          <p:cNvPr id="16" name="Object37">
            <a:extLst>
              <a:ext uri="{FF2B5EF4-FFF2-40B4-BE49-F238E27FC236}">
                <a16:creationId xmlns:a16="http://schemas.microsoft.com/office/drawing/2014/main" id="{0291F07F-3CC9-349B-6D6C-D66B830220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 bwMode="auto">
          <a:xfrm>
            <a:off x="279264" y="3215595"/>
            <a:ext cx="3599815" cy="1711325"/>
          </a:xfrm>
          <a:prstGeom prst="rect">
            <a:avLst/>
          </a:prstGeom>
          <a:noFill/>
        </p:spPr>
      </p:pic>
      <p:pic>
        <p:nvPicPr>
          <p:cNvPr id="17" name="Object38">
            <a:extLst>
              <a:ext uri="{FF2B5EF4-FFF2-40B4-BE49-F238E27FC236}">
                <a16:creationId xmlns:a16="http://schemas.microsoft.com/office/drawing/2014/main" id="{4352DFCD-E72B-0804-86F7-4DD6E44C6F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 bwMode="auto">
          <a:xfrm>
            <a:off x="4154578" y="3312472"/>
            <a:ext cx="3599815" cy="1711325"/>
          </a:xfrm>
          <a:prstGeom prst="rect">
            <a:avLst/>
          </a:prstGeom>
          <a:noFill/>
        </p:spPr>
      </p:pic>
      <p:pic>
        <p:nvPicPr>
          <p:cNvPr id="18" name="Object39">
            <a:extLst>
              <a:ext uri="{FF2B5EF4-FFF2-40B4-BE49-F238E27FC236}">
                <a16:creationId xmlns:a16="http://schemas.microsoft.com/office/drawing/2014/main" id="{A1A86268-2DB3-24E7-0CB2-CF80BCAC03A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 bwMode="auto">
          <a:xfrm>
            <a:off x="8247606" y="3215594"/>
            <a:ext cx="3599815" cy="171132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1754470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43</Words>
  <Application>Microsoft Office PowerPoint</Application>
  <PresentationFormat>Widescreen</PresentationFormat>
  <Paragraphs>8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Liberation Serif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abriele Melegari</dc:creator>
  <cp:lastModifiedBy>Gabriele Melegari</cp:lastModifiedBy>
  <cp:revision>2</cp:revision>
  <dcterms:created xsi:type="dcterms:W3CDTF">2025-10-10T09:14:32Z</dcterms:created>
  <dcterms:modified xsi:type="dcterms:W3CDTF">2026-02-19T14:17:08Z</dcterms:modified>
</cp:coreProperties>
</file>